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5"/>
  </p:notesMasterIdLst>
  <p:sldIdLst>
    <p:sldId id="269" r:id="rId2"/>
    <p:sldId id="271" r:id="rId3"/>
    <p:sldId id="256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4C1A8A3-306A-4EB7-A6B1-4F7E0EB9C5D6}" styleName="中間スタイル 3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59"/>
    <p:restoredTop sz="92261"/>
  </p:normalViewPr>
  <p:slideViewPr>
    <p:cSldViewPr snapToGrid="0" snapToObjects="1" showGuides="1">
      <p:cViewPr varScale="1">
        <p:scale>
          <a:sx n="69" d="100"/>
          <a:sy n="69" d="100"/>
        </p:scale>
        <p:origin x="1590" y="60"/>
      </p:cViewPr>
      <p:guideLst>
        <p:guide orient="horz" pos="213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072FFD-D1E2-D14E-9438-FE6D5DBC0C70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55DEE0-6B7F-DC4A-B6E6-8DF020C6F8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89114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49C7126-9BDF-1546-A736-EACA32FA7B93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54213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89BF5-C8F2-4443-87D2-22B7F98FE0B3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9DC7-2325-8645-ADF3-019228349D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2827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89BF5-C8F2-4443-87D2-22B7F98FE0B3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9DC7-2325-8645-ADF3-019228349D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312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89BF5-C8F2-4443-87D2-22B7F98FE0B3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9DC7-2325-8645-ADF3-019228349D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2707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89BF5-C8F2-4443-87D2-22B7F98FE0B3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9DC7-2325-8645-ADF3-019228349D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1329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89BF5-C8F2-4443-87D2-22B7F98FE0B3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9DC7-2325-8645-ADF3-019228349D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7858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89BF5-C8F2-4443-87D2-22B7F98FE0B3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9DC7-2325-8645-ADF3-019228349D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6959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89BF5-C8F2-4443-87D2-22B7F98FE0B3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9DC7-2325-8645-ADF3-019228349D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4032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89BF5-C8F2-4443-87D2-22B7F98FE0B3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9DC7-2325-8645-ADF3-019228349D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3531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89BF5-C8F2-4443-87D2-22B7F98FE0B3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9DC7-2325-8645-ADF3-019228349D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2342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89BF5-C8F2-4443-87D2-22B7F98FE0B3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9DC7-2325-8645-ADF3-019228349D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6856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789BF5-C8F2-4443-87D2-22B7F98FE0B3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39DC7-2325-8645-ADF3-019228349D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792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789BF5-C8F2-4443-87D2-22B7F98FE0B3}" type="datetimeFigureOut">
              <a:rPr kumimoji="1" lang="ja-JP" altLang="en-US" smtClean="0"/>
              <a:t>2020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339DC7-2325-8645-ADF3-019228349D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1259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xmlns="" id="{F585561A-36FF-AF46-87D3-A27C2BAF11DC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18274239"/>
              </p:ext>
            </p:extLst>
          </p:nvPr>
        </p:nvGraphicFramePr>
        <p:xfrm>
          <a:off x="628650" y="1782350"/>
          <a:ext cx="7886700" cy="3972273"/>
        </p:xfrm>
        <a:graphic>
          <a:graphicData uri="http://schemas.openxmlformats.org/drawingml/2006/table">
            <a:tbl>
              <a:tblPr firstRow="1" firstCol="1" bandRow="1"/>
              <a:tblGrid>
                <a:gridCol w="2095211">
                  <a:extLst>
                    <a:ext uri="{9D8B030D-6E8A-4147-A177-3AD203B41FA5}">
                      <a16:colId xmlns:a16="http://schemas.microsoft.com/office/drawing/2014/main" xmlns="" val="273695439"/>
                    </a:ext>
                  </a:extLst>
                </a:gridCol>
                <a:gridCol w="5791489">
                  <a:extLst>
                    <a:ext uri="{9D8B030D-6E8A-4147-A177-3AD203B41FA5}">
                      <a16:colId xmlns:a16="http://schemas.microsoft.com/office/drawing/2014/main" xmlns="" val="3666922203"/>
                    </a:ext>
                  </a:extLst>
                </a:gridCol>
              </a:tblGrid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Primer name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Primer sequence 5` - 3`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50516085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llumina AITS-F</a:t>
                      </a:r>
                      <a:r>
                        <a:rPr lang="en-US" sz="800" baseline="30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 a</a:t>
                      </a: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   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CACTCTTTCCCTACACGACGCTCTTCCGATCTNNCGAAAGTTCACCGATATTG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23683143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llumina AITS-R</a:t>
                      </a:r>
                      <a:r>
                        <a:rPr lang="en-US" sz="800" baseline="30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 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GTGACTGGAGTTCAGACGTGTGCTCTTCCGATCTNNAGGAAGCCAAGTCATCCAT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5219358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NITS_F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[index1-12]-CGGAAGTTCACCGATATTG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99516506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NITS_R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[index1-12]-AGGAAGCCAAGTCATCCAT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90035827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ndex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TATACAGCATGA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81321341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ndex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GAGTCTAGCTAG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81615158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ndex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TGCGACACATGTG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77243731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ndex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GACTATGCAGTG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41305089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ndex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CGCGTGCATCTA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03735909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ndex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TCGAGTAGTCTCA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60274736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ndex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GTATCATGTCAG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708683241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ndex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GCTAGTAGCTAC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80785227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ndex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CGAGACGATACTC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77685435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ndex1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TAGATGCTCGCGAG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78340517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ndex1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GCTACGCTGAGTA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79134113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ndex1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TCTCAGCGCAGTG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65261440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RA F</a:t>
                      </a:r>
                      <a:r>
                        <a:rPr lang="en-US" sz="800" baseline="30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TAGTGACAAGATGCGTACTCAACG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93613008"/>
                  </a:ext>
                </a:extLst>
              </a:tr>
              <a:tr h="20906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RA R</a:t>
                      </a:r>
                      <a:r>
                        <a:rPr lang="en-US" sz="800" baseline="300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ATGTGTTCGAGTACTTCGGTCACGCT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46193950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586B2456-BD93-0749-8174-13B7C7727929}"/>
              </a:ext>
            </a:extLst>
          </p:cNvPr>
          <p:cNvSpPr txBox="1"/>
          <p:nvPr/>
        </p:nvSpPr>
        <p:spPr>
          <a:xfrm>
            <a:off x="628650" y="5925312"/>
            <a:ext cx="466267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aseline="30000" dirty="0"/>
              <a:t>a</a:t>
            </a:r>
            <a:r>
              <a:rPr lang="en-US" sz="1100" dirty="0"/>
              <a:t> Illumina AITS -  (Gaithuma,2019) </a:t>
            </a:r>
          </a:p>
          <a:p>
            <a:r>
              <a:rPr lang="en-US" sz="1100" baseline="30000" dirty="0"/>
              <a:t>b</a:t>
            </a:r>
            <a:r>
              <a:rPr lang="en-US" sz="1100" dirty="0"/>
              <a:t> SRA -	       (Radwanska, 2002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C986F961-80D7-844D-8A76-9DC1FA880ADF}"/>
              </a:ext>
            </a:extLst>
          </p:cNvPr>
          <p:cNvSpPr txBox="1"/>
          <p:nvPr/>
        </p:nvSpPr>
        <p:spPr>
          <a:xfrm>
            <a:off x="780288" y="963168"/>
            <a:ext cx="53430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1: Table showing primers and primer sequences</a:t>
            </a:r>
          </a:p>
        </p:txBody>
      </p:sp>
    </p:spTree>
    <p:extLst>
      <p:ext uri="{BB962C8B-B14F-4D97-AF65-F5344CB8AC3E}">
        <p14:creationId xmlns:p14="http://schemas.microsoft.com/office/powerpoint/2010/main" val="11187985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xmlns="" id="{EA62FAA3-C972-0E46-AEB0-D59F31041DEC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45979347"/>
              </p:ext>
            </p:extLst>
          </p:nvPr>
        </p:nvGraphicFramePr>
        <p:xfrm>
          <a:off x="1189483" y="1484059"/>
          <a:ext cx="5877242" cy="2391952"/>
        </p:xfrm>
        <a:graphic>
          <a:graphicData uri="http://schemas.openxmlformats.org/drawingml/2006/table">
            <a:tbl>
              <a:tblPr firstRow="1" firstCol="1" bandRow="1"/>
              <a:tblGrid>
                <a:gridCol w="3004717">
                  <a:extLst>
                    <a:ext uri="{9D8B030D-6E8A-4147-A177-3AD203B41FA5}">
                      <a16:colId xmlns:a16="http://schemas.microsoft.com/office/drawing/2014/main" xmlns="" val="1163492205"/>
                    </a:ext>
                  </a:extLst>
                </a:gridCol>
                <a:gridCol w="2872525">
                  <a:extLst>
                    <a:ext uri="{9D8B030D-6E8A-4147-A177-3AD203B41FA5}">
                      <a16:colId xmlns:a16="http://schemas.microsoft.com/office/drawing/2014/main" xmlns="" val="2069803674"/>
                    </a:ext>
                  </a:extLst>
                </a:gridCol>
              </a:tblGrid>
              <a:tr h="29899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D/Species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GenBank Accession numbers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09745071"/>
                  </a:ext>
                </a:extLst>
              </a:tr>
              <a:tr h="29899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BankIt2278458 20Sable      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MN63573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18649266"/>
                  </a:ext>
                </a:extLst>
              </a:tr>
              <a:tr h="29899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BankIt2278458 90VervetMonkey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MN63573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85032165"/>
                  </a:ext>
                </a:extLst>
              </a:tr>
              <a:tr h="29899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BankIt2278458 38Buffalo    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MN63574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36471814"/>
                  </a:ext>
                </a:extLst>
              </a:tr>
              <a:tr h="29899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BankIt2278458 36Buffalo    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MN63574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34456262"/>
                  </a:ext>
                </a:extLst>
              </a:tr>
              <a:tr h="29899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BankIt2278458 39Buffalo    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MN63574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55027454"/>
                  </a:ext>
                </a:extLst>
              </a:tr>
              <a:tr h="29899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BankIt2278458 43Buffalo    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MN63574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27509555"/>
                  </a:ext>
                </a:extLst>
              </a:tr>
              <a:tr h="29899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BankIt2278458 46Buffalo    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1D2228"/>
                          </a:solidFill>
                          <a:effectLst/>
                          <a:latin typeface="Helvetica Neue" panose="02000503000000020004" pitchFamily="2" charset="0"/>
                          <a:ea typeface="Times New Roman" panose="02020603050405020304" pitchFamily="18" charset="0"/>
                        </a:rPr>
                        <a:t>MN63574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546541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87297FA7-B8A0-6344-9EF1-8D6754734925}"/>
              </a:ext>
            </a:extLst>
          </p:cNvPr>
          <p:cNvSpPr txBox="1"/>
          <p:nvPr/>
        </p:nvSpPr>
        <p:spPr>
          <a:xfrm>
            <a:off x="1676365" y="858795"/>
            <a:ext cx="45929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2: Table of GenBank Accession Numbers</a:t>
            </a:r>
          </a:p>
        </p:txBody>
      </p:sp>
    </p:spTree>
    <p:extLst>
      <p:ext uri="{BB962C8B-B14F-4D97-AF65-F5344CB8AC3E}">
        <p14:creationId xmlns:p14="http://schemas.microsoft.com/office/powerpoint/2010/main" val="38284616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>
            <a:extLst>
              <a:ext uri="{FF2B5EF4-FFF2-40B4-BE49-F238E27FC236}">
                <a16:creationId xmlns:a16="http://schemas.microsoft.com/office/drawing/2014/main" xmlns="" id="{7D94F67A-C857-4C4F-84D5-76135304BBAA}"/>
              </a:ext>
            </a:extLst>
          </p:cNvPr>
          <p:cNvSpPr/>
          <p:nvPr/>
        </p:nvSpPr>
        <p:spPr>
          <a:xfrm>
            <a:off x="5502728" y="3396342"/>
            <a:ext cx="175080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900" dirty="0"/>
              <a:t>(</a:t>
            </a:r>
            <a:r>
              <a:rPr lang="en-US" altLang="ja-JP" sz="900" dirty="0" err="1"/>
              <a:t>Template:</a:t>
            </a:r>
            <a:r>
              <a:rPr lang="en-US" altLang="ja-JP" sz="900" i="1" dirty="0" err="1"/>
              <a:t>T</a:t>
            </a:r>
            <a:r>
              <a:rPr lang="en-US" altLang="ja-JP" sz="900" i="1" dirty="0"/>
              <a:t>. b. rhodesiense </a:t>
            </a:r>
            <a:r>
              <a:rPr lang="en-US" altLang="ja-JP" sz="900" dirty="0"/>
              <a:t>DNA)</a:t>
            </a:r>
            <a:endParaRPr lang="ja-JP" altLang="en-US" sz="90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xmlns="" id="{A66B6D9E-BD3E-1844-B5F7-B9B7B6E6FC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1686" y="2890157"/>
            <a:ext cx="5081042" cy="2852234"/>
          </a:xfrm>
          <a:prstGeom prst="rect">
            <a:avLst/>
          </a:prstGeom>
        </p:spPr>
      </p:pic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xmlns="" id="{03CA9391-1EF3-4144-A3DD-1AA577C65D07}"/>
              </a:ext>
            </a:extLst>
          </p:cNvPr>
          <p:cNvSpPr/>
          <p:nvPr/>
        </p:nvSpPr>
        <p:spPr>
          <a:xfrm>
            <a:off x="3108217" y="3147401"/>
            <a:ext cx="1915909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/>
              <a:t>10</a:t>
            </a:r>
            <a:r>
              <a:rPr lang="en-US" altLang="ja-JP" sz="1050" baseline="30000" dirty="0"/>
              <a:t>3</a:t>
            </a:r>
            <a:r>
              <a:rPr lang="en-US" altLang="ja-JP" sz="1050" dirty="0"/>
              <a:t>   10</a:t>
            </a:r>
            <a:r>
              <a:rPr lang="en-US" altLang="ja-JP" sz="1050" baseline="30000" dirty="0"/>
              <a:t>2 </a:t>
            </a:r>
            <a:r>
              <a:rPr lang="en-US" altLang="ja-JP" sz="1050" dirty="0"/>
              <a:t> 10</a:t>
            </a:r>
            <a:r>
              <a:rPr lang="en-US" altLang="ja-JP" sz="1050" baseline="30000" dirty="0"/>
              <a:t>1     </a:t>
            </a:r>
            <a:r>
              <a:rPr lang="en-US" altLang="ja-JP" sz="1050" dirty="0"/>
              <a:t>10</a:t>
            </a:r>
            <a:r>
              <a:rPr lang="en-US" altLang="ja-JP" sz="1050" baseline="30000" dirty="0"/>
              <a:t>0</a:t>
            </a:r>
            <a:r>
              <a:rPr lang="en-US" altLang="ja-JP" sz="1050" dirty="0"/>
              <a:t>  10</a:t>
            </a:r>
            <a:r>
              <a:rPr lang="en-US" altLang="ja-JP" sz="1050" baseline="30000" dirty="0"/>
              <a:t>-1 </a:t>
            </a:r>
            <a:r>
              <a:rPr lang="en-US" altLang="ja-JP" sz="1050" dirty="0"/>
              <a:t>10</a:t>
            </a:r>
            <a:r>
              <a:rPr lang="en-US" altLang="ja-JP" sz="1050" baseline="30000" dirty="0"/>
              <a:t>-2  </a:t>
            </a:r>
            <a:r>
              <a:rPr lang="en-US" altLang="ja-JP" sz="1050" dirty="0"/>
              <a:t>10</a:t>
            </a:r>
            <a:r>
              <a:rPr lang="en-US" altLang="ja-JP" sz="1050" baseline="30000" dirty="0"/>
              <a:t>-3</a:t>
            </a:r>
            <a:endParaRPr lang="ja-JP" altLang="en-US" sz="1050" baseline="30000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xmlns="" id="{B3B6A715-039B-DA40-8DED-8122E67DADBE}"/>
              </a:ext>
            </a:extLst>
          </p:cNvPr>
          <p:cNvSpPr/>
          <p:nvPr/>
        </p:nvSpPr>
        <p:spPr>
          <a:xfrm>
            <a:off x="3433306" y="2916568"/>
            <a:ext cx="655949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/>
              <a:t>SRA-PCR</a:t>
            </a:r>
            <a:endParaRPr lang="ja-JP" altLang="en-US" sz="1050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xmlns="" id="{DEE02D87-1928-194B-A46C-77F8869D9511}"/>
              </a:ext>
            </a:extLst>
          </p:cNvPr>
          <p:cNvSpPr/>
          <p:nvPr/>
        </p:nvSpPr>
        <p:spPr>
          <a:xfrm>
            <a:off x="1106485" y="2890157"/>
            <a:ext cx="68159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/>
              <a:t>AITS-PCR</a:t>
            </a:r>
            <a:endParaRPr lang="ja-JP" altLang="en-US" sz="1050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xmlns="" id="{C22C2DB5-0B38-AE43-848E-3261641FCCEC}"/>
              </a:ext>
            </a:extLst>
          </p:cNvPr>
          <p:cNvSpPr/>
          <p:nvPr/>
        </p:nvSpPr>
        <p:spPr>
          <a:xfrm>
            <a:off x="758510" y="3165509"/>
            <a:ext cx="1915909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/>
              <a:t>10</a:t>
            </a:r>
            <a:r>
              <a:rPr lang="en-US" altLang="ja-JP" sz="1050" baseline="30000" dirty="0"/>
              <a:t>3</a:t>
            </a:r>
            <a:r>
              <a:rPr lang="en-US" altLang="ja-JP" sz="1050" dirty="0"/>
              <a:t>   10</a:t>
            </a:r>
            <a:r>
              <a:rPr lang="en-US" altLang="ja-JP" sz="1050" baseline="30000" dirty="0"/>
              <a:t>2 </a:t>
            </a:r>
            <a:r>
              <a:rPr lang="en-US" altLang="ja-JP" sz="1050" dirty="0"/>
              <a:t> 10</a:t>
            </a:r>
            <a:r>
              <a:rPr lang="en-US" altLang="ja-JP" sz="1050" baseline="30000" dirty="0"/>
              <a:t>1     </a:t>
            </a:r>
            <a:r>
              <a:rPr lang="en-US" altLang="ja-JP" sz="1050" dirty="0"/>
              <a:t>10</a:t>
            </a:r>
            <a:r>
              <a:rPr lang="en-US" altLang="ja-JP" sz="1050" baseline="30000" dirty="0"/>
              <a:t>0</a:t>
            </a:r>
            <a:r>
              <a:rPr lang="en-US" altLang="ja-JP" sz="1050" dirty="0"/>
              <a:t>  10</a:t>
            </a:r>
            <a:r>
              <a:rPr lang="en-US" altLang="ja-JP" sz="1050" baseline="30000" dirty="0"/>
              <a:t>-1 </a:t>
            </a:r>
            <a:r>
              <a:rPr lang="en-US" altLang="ja-JP" sz="1050" dirty="0"/>
              <a:t>10</a:t>
            </a:r>
            <a:r>
              <a:rPr lang="en-US" altLang="ja-JP" sz="1050" baseline="30000" dirty="0"/>
              <a:t>-2  </a:t>
            </a:r>
            <a:r>
              <a:rPr lang="en-US" altLang="ja-JP" sz="1050" dirty="0"/>
              <a:t>10</a:t>
            </a:r>
            <a:r>
              <a:rPr lang="en-US" altLang="ja-JP" sz="1050" baseline="30000" dirty="0"/>
              <a:t>-3</a:t>
            </a:r>
            <a:endParaRPr lang="ja-JP" altLang="en-US" sz="1050" baseline="30000"/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xmlns="" id="{ECBB3788-9330-7946-8C98-7A52A90F8984}"/>
              </a:ext>
            </a:extLst>
          </p:cNvPr>
          <p:cNvSpPr/>
          <p:nvPr/>
        </p:nvSpPr>
        <p:spPr>
          <a:xfrm>
            <a:off x="5542297" y="3101234"/>
            <a:ext cx="357790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350" dirty="0" err="1"/>
              <a:t>pg</a:t>
            </a:r>
            <a:endParaRPr lang="ja-JP" altLang="en-US" sz="135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DCE8DAF1-1D6A-FB45-B75A-2076B45DF7B7}"/>
              </a:ext>
            </a:extLst>
          </p:cNvPr>
          <p:cNvSpPr txBox="1"/>
          <p:nvPr/>
        </p:nvSpPr>
        <p:spPr>
          <a:xfrm>
            <a:off x="758509" y="771896"/>
            <a:ext cx="762546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xperimental data 3:</a:t>
            </a:r>
          </a:p>
          <a:p>
            <a:r>
              <a:rPr lang="en-US" b="1" dirty="0"/>
              <a:t>SRA-PCR and ITS1-PCR comparative </a:t>
            </a:r>
            <a:r>
              <a:rPr lang="aa-ET" b="1" dirty="0"/>
              <a:t>detection limit determination assay using </a:t>
            </a:r>
            <a:r>
              <a:rPr lang="aa-ET" b="1" i="1" dirty="0"/>
              <a:t>T. b. rhodesiense</a:t>
            </a:r>
            <a:r>
              <a:rPr lang="aa-ET" b="1" dirty="0"/>
              <a:t> IL1501 pure DNA</a:t>
            </a:r>
            <a:r>
              <a:rPr lang="en-US" b="1" dirty="0"/>
              <a:t>. </a:t>
            </a:r>
            <a:endParaRPr lang="aa-ET" dirty="0"/>
          </a:p>
          <a:p>
            <a:endParaRPr lang="aa-ET" dirty="0"/>
          </a:p>
        </p:txBody>
      </p:sp>
    </p:spTree>
    <p:extLst>
      <p:ext uri="{BB962C8B-B14F-4D97-AF65-F5344CB8AC3E}">
        <p14:creationId xmlns:p14="http://schemas.microsoft.com/office/powerpoint/2010/main" val="759280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36</TotalTime>
  <Words>157</Words>
  <Application>Microsoft Office PowerPoint</Application>
  <PresentationFormat>On-screen Show (4:3)</PresentationFormat>
  <Paragraphs>67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1" baseType="lpstr">
      <vt:lpstr>游ゴシック</vt:lpstr>
      <vt:lpstr>游ゴシック Light</vt:lpstr>
      <vt:lpstr>Arial</vt:lpstr>
      <vt:lpstr>Calibri</vt:lpstr>
      <vt:lpstr>Calibri Light</vt:lpstr>
      <vt:lpstr>Helvetica Neue</vt:lpstr>
      <vt:lpstr>Times New Roman</vt:lpstr>
      <vt:lpstr>Office テーマ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yokoHayashida</dc:creator>
  <cp:lastModifiedBy>Manickam U.</cp:lastModifiedBy>
  <cp:revision>70</cp:revision>
  <cp:lastPrinted>2019-10-31T07:23:28Z</cp:lastPrinted>
  <dcterms:created xsi:type="dcterms:W3CDTF">2019-06-25T00:08:01Z</dcterms:created>
  <dcterms:modified xsi:type="dcterms:W3CDTF">2020-04-18T15:22:03Z</dcterms:modified>
</cp:coreProperties>
</file>